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1992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0325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401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831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84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710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9599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3798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00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51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7985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29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649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BE2B2128-8215-3C64-93FC-7378406D8BBB}"/>
              </a:ext>
            </a:extLst>
          </p:cNvPr>
          <p:cNvSpPr txBox="1"/>
          <p:nvPr/>
        </p:nvSpPr>
        <p:spPr>
          <a:xfrm>
            <a:off x="309880" y="182880"/>
            <a:ext cx="6236971" cy="14441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5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4+ T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fter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eiv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l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edul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ains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VID-19,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rmin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CD3+CD8-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WH (ope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os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coxon signed-rank test was applied to calculate the statistical significance within groups. Mann-Whitney U test was applied to calculate the statistical significance between unpaired group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F8E712C6-264F-2226-B35E-6211C297CF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568063"/>
              </p:ext>
            </p:extLst>
          </p:nvPr>
        </p:nvGraphicFramePr>
        <p:xfrm>
          <a:off x="2005013" y="3611563"/>
          <a:ext cx="2849562" cy="1920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76122" imgH="2741468" progId="Prism8.Document">
                  <p:embed/>
                </p:oleObj>
              </mc:Choice>
              <mc:Fallback>
                <p:oleObj name="Prism 8" r:id="rId2" imgW="4076122" imgH="2741468" progId="Prism8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F8E712C6-264F-2226-B35E-6211C297CF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05013" y="3611563"/>
                        <a:ext cx="2849562" cy="1920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791787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3</TotalTime>
  <Words>7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sado Fernández Guiomar</dc:creator>
  <cp:lastModifiedBy>Megan Bond</cp:lastModifiedBy>
  <cp:revision>69</cp:revision>
  <dcterms:created xsi:type="dcterms:W3CDTF">2022-01-10T11:03:11Z</dcterms:created>
  <dcterms:modified xsi:type="dcterms:W3CDTF">2024-05-01T12:43:22Z</dcterms:modified>
</cp:coreProperties>
</file>